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42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89" y="5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최동혁" userId="edc1c042-be42-4790-af0a-3f3978db11fc" providerId="ADAL" clId="{0599124D-63AA-4982-8884-8DA36F1B97EB}"/>
    <pc:docChg chg="custSel modSld">
      <pc:chgData name="최동혁" userId="edc1c042-be42-4790-af0a-3f3978db11fc" providerId="ADAL" clId="{0599124D-63AA-4982-8884-8DA36F1B97EB}" dt="2023-09-21T05:34:35.482" v="1"/>
      <pc:docMkLst>
        <pc:docMk/>
      </pc:docMkLst>
      <pc:sldChg chg="delSp modSp mod">
        <pc:chgData name="최동혁" userId="edc1c042-be42-4790-af0a-3f3978db11fc" providerId="ADAL" clId="{0599124D-63AA-4982-8884-8DA36F1B97EB}" dt="2023-09-21T05:34:35.482" v="1"/>
        <pc:sldMkLst>
          <pc:docMk/>
          <pc:sldMk cId="4058215316" sldId="257"/>
        </pc:sldMkLst>
        <pc:spChg chg="del">
          <ac:chgData name="최동혁" userId="edc1c042-be42-4790-af0a-3f3978db11fc" providerId="ADAL" clId="{0599124D-63AA-4982-8884-8DA36F1B97EB}" dt="2023-09-21T05:34:07.065" v="0" actId="478"/>
          <ac:spMkLst>
            <pc:docMk/>
            <pc:sldMk cId="4058215316" sldId="257"/>
            <ac:spMk id="2" creationId="{00000000-0000-0000-0000-000000000000}"/>
          </ac:spMkLst>
        </pc:spChg>
        <pc:spChg chg="mod">
          <ac:chgData name="최동혁" userId="edc1c042-be42-4790-af0a-3f3978db11fc" providerId="ADAL" clId="{0599124D-63AA-4982-8884-8DA36F1B97EB}" dt="2023-09-21T05:34:35.482" v="1"/>
          <ac:spMkLst>
            <pc:docMk/>
            <pc:sldMk cId="4058215316" sldId="257"/>
            <ac:spMk id="12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BECE3-0608-42C6-8794-DAA951C43466}" type="datetimeFigureOut">
              <a:rPr lang="ko-KR" altLang="en-US" smtClean="0"/>
              <a:t>2023-09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2B32A-2608-4238-965E-16F51BFA57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980369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BECE3-0608-42C6-8794-DAA951C43466}" type="datetimeFigureOut">
              <a:rPr lang="ko-KR" altLang="en-US" smtClean="0"/>
              <a:t>2023-09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2B32A-2608-4238-965E-16F51BFA57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253003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BECE3-0608-42C6-8794-DAA951C43466}" type="datetimeFigureOut">
              <a:rPr lang="ko-KR" altLang="en-US" smtClean="0"/>
              <a:t>2023-09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2B32A-2608-4238-965E-16F51BFA57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908716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BECE3-0608-42C6-8794-DAA951C43466}" type="datetimeFigureOut">
              <a:rPr lang="ko-KR" altLang="en-US" smtClean="0"/>
              <a:t>2023-09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2B32A-2608-4238-965E-16F51BFA57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775332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BECE3-0608-42C6-8794-DAA951C43466}" type="datetimeFigureOut">
              <a:rPr lang="ko-KR" altLang="en-US" smtClean="0"/>
              <a:t>2023-09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2B32A-2608-4238-965E-16F51BFA57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640740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BECE3-0608-42C6-8794-DAA951C43466}" type="datetimeFigureOut">
              <a:rPr lang="ko-KR" altLang="en-US" smtClean="0"/>
              <a:t>2023-09-2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2B32A-2608-4238-965E-16F51BFA57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25196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BECE3-0608-42C6-8794-DAA951C43466}" type="datetimeFigureOut">
              <a:rPr lang="ko-KR" altLang="en-US" smtClean="0"/>
              <a:t>2023-09-2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2B32A-2608-4238-965E-16F51BFA57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380647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BECE3-0608-42C6-8794-DAA951C43466}" type="datetimeFigureOut">
              <a:rPr lang="ko-KR" altLang="en-US" smtClean="0"/>
              <a:t>2023-09-2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2B32A-2608-4238-965E-16F51BFA57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932346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BECE3-0608-42C6-8794-DAA951C43466}" type="datetimeFigureOut">
              <a:rPr lang="ko-KR" altLang="en-US" smtClean="0"/>
              <a:t>2023-09-2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2B32A-2608-4238-965E-16F51BFA57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09497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BECE3-0608-42C6-8794-DAA951C43466}" type="datetimeFigureOut">
              <a:rPr lang="ko-KR" altLang="en-US" smtClean="0"/>
              <a:t>2023-09-2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2B32A-2608-4238-965E-16F51BFA57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906628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BECE3-0608-42C6-8794-DAA951C43466}" type="datetimeFigureOut">
              <a:rPr lang="ko-KR" altLang="en-US" smtClean="0"/>
              <a:t>2023-09-2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2B32A-2608-4238-965E-16F51BFA57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777430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9BECE3-0608-42C6-8794-DAA951C43466}" type="datetimeFigureOut">
              <a:rPr lang="ko-KR" altLang="en-US" smtClean="0"/>
              <a:t>2023-09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32B32A-2608-4238-965E-16F51BFA572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046423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직사각형 21"/>
          <p:cNvSpPr/>
          <p:nvPr/>
        </p:nvSpPr>
        <p:spPr>
          <a:xfrm>
            <a:off x="6811926" y="3742870"/>
            <a:ext cx="2133600" cy="1452907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" name="포인트가 7개인 별 3"/>
          <p:cNvSpPr/>
          <p:nvPr/>
        </p:nvSpPr>
        <p:spPr>
          <a:xfrm>
            <a:off x="2254685" y="1878903"/>
            <a:ext cx="206680" cy="212943"/>
          </a:xfrm>
          <a:prstGeom prst="star7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" name="이등변 삼각형 4"/>
          <p:cNvSpPr/>
          <p:nvPr/>
        </p:nvSpPr>
        <p:spPr>
          <a:xfrm>
            <a:off x="1975981" y="2135687"/>
            <a:ext cx="764087" cy="2379945"/>
          </a:xfrm>
          <a:prstGeom prst="triangle">
            <a:avLst/>
          </a:prstGeom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" name="타원 5"/>
          <p:cNvSpPr/>
          <p:nvPr/>
        </p:nvSpPr>
        <p:spPr>
          <a:xfrm>
            <a:off x="1681618" y="2578686"/>
            <a:ext cx="1352811" cy="201130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" name="TextBox 6"/>
          <p:cNvSpPr txBox="1"/>
          <p:nvPr/>
        </p:nvSpPr>
        <p:spPr>
          <a:xfrm>
            <a:off x="3034429" y="2502817"/>
            <a:ext cx="11680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Gantry head</a:t>
            </a:r>
            <a:endParaRPr lang="ko-KR" altLang="en-US" sz="1200" dirty="0"/>
          </a:p>
        </p:txBody>
      </p:sp>
      <p:cxnSp>
        <p:nvCxnSpPr>
          <p:cNvPr id="10" name="직선 연결선 9"/>
          <p:cNvCxnSpPr/>
          <p:nvPr/>
        </p:nvCxnSpPr>
        <p:spPr>
          <a:xfrm flipV="1">
            <a:off x="1681618" y="2821658"/>
            <a:ext cx="1352811" cy="0"/>
          </a:xfrm>
          <a:prstGeom prst="line">
            <a:avLst/>
          </a:prstGeom>
          <a:ln w="73025"/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3021078" y="2717185"/>
            <a:ext cx="13178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Stealth chamber</a:t>
            </a:r>
            <a:endParaRPr lang="ko-KR" altLang="en-US" sz="1200" dirty="0"/>
          </a:p>
        </p:txBody>
      </p:sp>
      <p:sp>
        <p:nvSpPr>
          <p:cNvPr id="12" name="TextBox 11"/>
          <p:cNvSpPr txBox="1"/>
          <p:nvPr/>
        </p:nvSpPr>
        <p:spPr>
          <a:xfrm>
            <a:off x="1137099" y="4796287"/>
            <a:ext cx="255624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To measure the output factor up to 25x25 cm² with a stealth chamber, it is installed directly on the gantry.</a:t>
            </a:r>
            <a:endParaRPr lang="ko-KR" altLang="en-US" sz="1200" dirty="0"/>
          </a:p>
        </p:txBody>
      </p:sp>
      <p:sp>
        <p:nvSpPr>
          <p:cNvPr id="13" name="포인트가 7개인 별 12"/>
          <p:cNvSpPr/>
          <p:nvPr/>
        </p:nvSpPr>
        <p:spPr>
          <a:xfrm>
            <a:off x="7772983" y="1740680"/>
            <a:ext cx="206680" cy="212943"/>
          </a:xfrm>
          <a:prstGeom prst="star7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4" name="이등변 삼각형 13"/>
          <p:cNvSpPr/>
          <p:nvPr/>
        </p:nvSpPr>
        <p:spPr>
          <a:xfrm>
            <a:off x="7494279" y="1997464"/>
            <a:ext cx="764087" cy="2379945"/>
          </a:xfrm>
          <a:prstGeom prst="triangle">
            <a:avLst/>
          </a:prstGeom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8" name="TextBox 17"/>
          <p:cNvSpPr txBox="1"/>
          <p:nvPr/>
        </p:nvSpPr>
        <p:spPr>
          <a:xfrm>
            <a:off x="7320747" y="4893895"/>
            <a:ext cx="13178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Water phantom</a:t>
            </a:r>
            <a:endParaRPr lang="ko-KR" altLang="en-US" sz="1200" dirty="0"/>
          </a:p>
        </p:txBody>
      </p:sp>
      <p:cxnSp>
        <p:nvCxnSpPr>
          <p:cNvPr id="20" name="직선 화살표 연결선 19"/>
          <p:cNvCxnSpPr/>
          <p:nvPr/>
        </p:nvCxnSpPr>
        <p:spPr>
          <a:xfrm>
            <a:off x="8486445" y="1878903"/>
            <a:ext cx="0" cy="1863967"/>
          </a:xfrm>
          <a:prstGeom prst="straightConnector1">
            <a:avLst/>
          </a:prstGeom>
          <a:ln>
            <a:headEnd type="triangle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8495474" y="2672386"/>
            <a:ext cx="11680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SSD=95cn</a:t>
            </a:r>
            <a:endParaRPr lang="ko-KR" altLang="en-US" sz="1200" dirty="0"/>
          </a:p>
        </p:txBody>
      </p:sp>
      <p:cxnSp>
        <p:nvCxnSpPr>
          <p:cNvPr id="23" name="직선 화살표 연결선 22"/>
          <p:cNvCxnSpPr/>
          <p:nvPr/>
        </p:nvCxnSpPr>
        <p:spPr>
          <a:xfrm>
            <a:off x="8486445" y="3742870"/>
            <a:ext cx="0" cy="414879"/>
          </a:xfrm>
          <a:prstGeom prst="straightConnector1">
            <a:avLst/>
          </a:prstGeom>
          <a:ln>
            <a:headEnd type="triangle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8451004" y="3808053"/>
            <a:ext cx="11680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Depth=5cn</a:t>
            </a:r>
            <a:endParaRPr lang="ko-KR" altLang="en-US" sz="1200" dirty="0"/>
          </a:p>
        </p:txBody>
      </p:sp>
      <p:sp>
        <p:nvSpPr>
          <p:cNvPr id="26" name="타원 25"/>
          <p:cNvSpPr/>
          <p:nvPr/>
        </p:nvSpPr>
        <p:spPr>
          <a:xfrm>
            <a:off x="7798738" y="4052499"/>
            <a:ext cx="148856" cy="153795"/>
          </a:xfrm>
          <a:prstGeom prst="ellipse">
            <a:avLst/>
          </a:prstGeom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7" name="TextBox 26"/>
          <p:cNvSpPr txBox="1"/>
          <p:nvPr/>
        </p:nvSpPr>
        <p:spPr>
          <a:xfrm>
            <a:off x="7312263" y="3990896"/>
            <a:ext cx="6620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CC13</a:t>
            </a:r>
            <a:endParaRPr lang="ko-KR" altLang="en-US" sz="1200" dirty="0"/>
          </a:p>
        </p:txBody>
      </p:sp>
    </p:spTree>
    <p:extLst>
      <p:ext uri="{BB962C8B-B14F-4D97-AF65-F5344CB8AC3E}">
        <p14:creationId xmlns:p14="http://schemas.microsoft.com/office/powerpoint/2010/main" val="40582153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5</Words>
  <Application>Microsoft Office PowerPoint</Application>
  <PresentationFormat>와이드스크린</PresentationFormat>
  <Paragraphs>7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reviewer</dc:creator>
  <cp:lastModifiedBy>최동혁</cp:lastModifiedBy>
  <cp:revision>2</cp:revision>
  <dcterms:created xsi:type="dcterms:W3CDTF">2023-09-17T00:53:56Z</dcterms:created>
  <dcterms:modified xsi:type="dcterms:W3CDTF">2023-09-21T05:34:36Z</dcterms:modified>
</cp:coreProperties>
</file>